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00"/>
    <a:srgbClr val="660066"/>
    <a:srgbClr val="80008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-468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4296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4932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31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3760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1875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91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3079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5261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8838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7845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548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2458FE-AA95-467D-BDC3-B5DD6C2B4C46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B89E9-B6A0-45D9-BC79-5D0FA4AF69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5601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/>
          <p:cNvSpPr txBox="1"/>
          <p:nvPr/>
        </p:nvSpPr>
        <p:spPr>
          <a:xfrm>
            <a:off x="1457201" y="1304146"/>
            <a:ext cx="156215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23A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mologues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</a:p>
          <a:p>
            <a:pPr algn="r"/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citri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. </a:t>
            </a:r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scans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phaseoli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v. </a:t>
            </a:r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oli</a:t>
            </a:r>
            <a:endParaRPr lang="fr-FR" sz="11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1318897" y="2075204"/>
            <a:ext cx="170046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18G and TAL20F:</a:t>
            </a:r>
          </a:p>
          <a:p>
            <a:pPr algn="r"/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citri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. </a:t>
            </a:r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scans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F2)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906378" y="2685842"/>
            <a:ext cx="211298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18H: </a:t>
            </a:r>
          </a:p>
          <a:p>
            <a:pPr algn="r"/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citri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.</a:t>
            </a:r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scans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uscans) and </a:t>
            </a:r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phaseoli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. </a:t>
            </a:r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oli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F1)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1318896" y="3505253"/>
            <a:ext cx="17004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citri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.</a:t>
            </a:r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urantifolii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318896" y="4175201"/>
            <a:ext cx="17004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phaseoli pv. manihotis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riangle rectangle 13"/>
          <p:cNvSpPr/>
          <p:nvPr/>
        </p:nvSpPr>
        <p:spPr>
          <a:xfrm rot="5400000">
            <a:off x="4270838" y="1440129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riangle rectangle 14"/>
          <p:cNvSpPr/>
          <p:nvPr/>
        </p:nvSpPr>
        <p:spPr>
          <a:xfrm rot="5400000">
            <a:off x="7797160" y="1439180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riangle rectangle 15"/>
          <p:cNvSpPr/>
          <p:nvPr/>
        </p:nvSpPr>
        <p:spPr>
          <a:xfrm rot="5400000">
            <a:off x="8155318" y="1439180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riangle rectangle 16"/>
          <p:cNvSpPr/>
          <p:nvPr/>
        </p:nvSpPr>
        <p:spPr>
          <a:xfrm rot="5400000">
            <a:off x="8861170" y="2109998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riangle rectangle 18"/>
          <p:cNvSpPr/>
          <p:nvPr/>
        </p:nvSpPr>
        <p:spPr>
          <a:xfrm rot="5400000">
            <a:off x="7795896" y="3466242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4" name="Tableau 4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3295929"/>
              </p:ext>
            </p:extLst>
          </p:nvPr>
        </p:nvGraphicFramePr>
        <p:xfrm>
          <a:off x="3206516" y="930007"/>
          <a:ext cx="8127993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u="none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100" u="non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u="none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FR" sz="1100" u="non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u="none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fr-FR" sz="1100" u="non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lang="fr-FR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45" name="Triangle rectangle 44"/>
          <p:cNvSpPr/>
          <p:nvPr/>
        </p:nvSpPr>
        <p:spPr>
          <a:xfrm rot="5400000">
            <a:off x="3915132" y="1440129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riangle rectangle 45"/>
          <p:cNvSpPr/>
          <p:nvPr/>
        </p:nvSpPr>
        <p:spPr>
          <a:xfrm rot="16200000">
            <a:off x="7099780" y="1439760"/>
            <a:ext cx="352800" cy="342000"/>
          </a:xfrm>
          <a:prstGeom prst="rtTriangle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riangle rectangle 46"/>
          <p:cNvSpPr/>
          <p:nvPr/>
        </p:nvSpPr>
        <p:spPr>
          <a:xfrm rot="5400000">
            <a:off x="4978980" y="2786961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riangle rectangle 47"/>
          <p:cNvSpPr/>
          <p:nvPr/>
        </p:nvSpPr>
        <p:spPr>
          <a:xfrm rot="5400000">
            <a:off x="3563109" y="3466242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riangle rectangle 48"/>
          <p:cNvSpPr/>
          <p:nvPr/>
        </p:nvSpPr>
        <p:spPr>
          <a:xfrm rot="5400000">
            <a:off x="4268479" y="3466242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riangle rectangle 50"/>
          <p:cNvSpPr/>
          <p:nvPr/>
        </p:nvSpPr>
        <p:spPr>
          <a:xfrm rot="5400000">
            <a:off x="5321305" y="3466242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riangle rectangle 51"/>
          <p:cNvSpPr/>
          <p:nvPr/>
        </p:nvSpPr>
        <p:spPr>
          <a:xfrm rot="5400000">
            <a:off x="6039635" y="3466242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riangle rectangle 52"/>
          <p:cNvSpPr/>
          <p:nvPr/>
        </p:nvSpPr>
        <p:spPr>
          <a:xfrm rot="5400000">
            <a:off x="7445875" y="3466242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riangle rectangle 53"/>
          <p:cNvSpPr/>
          <p:nvPr/>
        </p:nvSpPr>
        <p:spPr>
          <a:xfrm rot="16200000">
            <a:off x="8153993" y="3466242"/>
            <a:ext cx="352800" cy="342000"/>
          </a:xfrm>
          <a:prstGeom prst="rtTriangle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ZoneTexte 54"/>
          <p:cNvSpPr txBox="1"/>
          <p:nvPr/>
        </p:nvSpPr>
        <p:spPr>
          <a:xfrm>
            <a:off x="1457201" y="975996"/>
            <a:ext cx="15621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on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1088194" y="4768999"/>
            <a:ext cx="1001561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6: Figure S7.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s conserved and shared between different TAL effectors from 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citri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.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scans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phaseoli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.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haseoli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citri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.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urantifolii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phaseoli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.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nihotis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rains. Repeats conserved between different TAL effectors are indicated by the same colour (red, purple, green, blue or yellow). Half-coloured boxes indicate that polymorphism exist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ng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ors homologues from different strains. Please see Additional file 15: Table S9 for more detailed information.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riangle rectangle 30"/>
          <p:cNvSpPr/>
          <p:nvPr/>
        </p:nvSpPr>
        <p:spPr>
          <a:xfrm rot="16200000">
            <a:off x="7794570" y="3461439"/>
            <a:ext cx="352800" cy="342000"/>
          </a:xfrm>
          <a:prstGeom prst="rt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riangle rectangle 31"/>
          <p:cNvSpPr/>
          <p:nvPr/>
        </p:nvSpPr>
        <p:spPr>
          <a:xfrm rot="16200000">
            <a:off x="8863275" y="3461439"/>
            <a:ext cx="352800" cy="342000"/>
          </a:xfrm>
          <a:prstGeom prst="rt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riangle rectangle 32"/>
          <p:cNvSpPr/>
          <p:nvPr/>
        </p:nvSpPr>
        <p:spPr>
          <a:xfrm rot="16200000">
            <a:off x="5681160" y="3461438"/>
            <a:ext cx="352800" cy="342000"/>
          </a:xfrm>
          <a:prstGeom prst="rtTriangl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riangle rectangle 33"/>
          <p:cNvSpPr/>
          <p:nvPr/>
        </p:nvSpPr>
        <p:spPr>
          <a:xfrm rot="16200000">
            <a:off x="3561047" y="3461437"/>
            <a:ext cx="352800" cy="342000"/>
          </a:xfrm>
          <a:prstGeom prst="rtTriangl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riangle rectangle 34"/>
          <p:cNvSpPr/>
          <p:nvPr/>
        </p:nvSpPr>
        <p:spPr>
          <a:xfrm rot="16200000">
            <a:off x="4265665" y="3461436"/>
            <a:ext cx="352800" cy="342000"/>
          </a:xfrm>
          <a:prstGeom prst="rtTriangl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riangle rectangle 35"/>
          <p:cNvSpPr/>
          <p:nvPr/>
        </p:nvSpPr>
        <p:spPr>
          <a:xfrm rot="16200000">
            <a:off x="4963839" y="3462880"/>
            <a:ext cx="352800" cy="342000"/>
          </a:xfrm>
          <a:prstGeom prst="rtTriangl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riangle rectangle 36"/>
          <p:cNvSpPr/>
          <p:nvPr/>
        </p:nvSpPr>
        <p:spPr>
          <a:xfrm rot="16200000">
            <a:off x="6030428" y="3462880"/>
            <a:ext cx="352800" cy="342000"/>
          </a:xfrm>
          <a:prstGeom prst="rtTriangle">
            <a:avLst/>
          </a:prstGeom>
          <a:solidFill>
            <a:srgbClr val="66006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riangle rectangle 37"/>
          <p:cNvSpPr/>
          <p:nvPr/>
        </p:nvSpPr>
        <p:spPr>
          <a:xfrm rot="16200000">
            <a:off x="3911853" y="1436914"/>
            <a:ext cx="352800" cy="342000"/>
          </a:xfrm>
          <a:prstGeom prst="rtTriangle">
            <a:avLst/>
          </a:prstGeom>
          <a:solidFill>
            <a:srgbClr val="66006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riangle rectangle 38"/>
          <p:cNvSpPr/>
          <p:nvPr/>
        </p:nvSpPr>
        <p:spPr>
          <a:xfrm rot="16200000">
            <a:off x="4271901" y="1436541"/>
            <a:ext cx="352800" cy="342000"/>
          </a:xfrm>
          <a:prstGeom prst="rtTriangle">
            <a:avLst/>
          </a:prstGeom>
          <a:solidFill>
            <a:srgbClr val="66006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riangle rectangle 39"/>
          <p:cNvSpPr/>
          <p:nvPr/>
        </p:nvSpPr>
        <p:spPr>
          <a:xfrm rot="16200000">
            <a:off x="4620090" y="2127793"/>
            <a:ext cx="352800" cy="342000"/>
          </a:xfrm>
          <a:prstGeom prst="rtTriangle">
            <a:avLst/>
          </a:prstGeom>
          <a:solidFill>
            <a:srgbClr val="66006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riangle rectangle 40"/>
          <p:cNvSpPr/>
          <p:nvPr/>
        </p:nvSpPr>
        <p:spPr>
          <a:xfrm rot="16200000">
            <a:off x="5674853" y="2118009"/>
            <a:ext cx="352800" cy="342000"/>
          </a:xfrm>
          <a:prstGeom prst="rtTriangle">
            <a:avLst/>
          </a:prstGeom>
          <a:solidFill>
            <a:srgbClr val="66006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riangle rectangle 41"/>
          <p:cNvSpPr/>
          <p:nvPr/>
        </p:nvSpPr>
        <p:spPr>
          <a:xfrm rot="5400000">
            <a:off x="5680128" y="3458781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riangle rectangle 42"/>
          <p:cNvSpPr/>
          <p:nvPr/>
        </p:nvSpPr>
        <p:spPr>
          <a:xfrm rot="5400000">
            <a:off x="8161852" y="3464326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riangle rectangle 49"/>
          <p:cNvSpPr/>
          <p:nvPr/>
        </p:nvSpPr>
        <p:spPr>
          <a:xfrm rot="5400000">
            <a:off x="4968775" y="3466242"/>
            <a:ext cx="352800" cy="342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au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2356818"/>
              </p:ext>
            </p:extLst>
          </p:nvPr>
        </p:nvGraphicFramePr>
        <p:xfrm>
          <a:off x="3206516" y="2788054"/>
          <a:ext cx="6361038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u="none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8" name="Tableau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1139994"/>
              </p:ext>
            </p:extLst>
          </p:nvPr>
        </p:nvGraphicFramePr>
        <p:xfrm>
          <a:off x="3206516" y="4120586"/>
          <a:ext cx="4947474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3198472"/>
              </p:ext>
            </p:extLst>
          </p:nvPr>
        </p:nvGraphicFramePr>
        <p:xfrm>
          <a:off x="3206516" y="2105227"/>
          <a:ext cx="706782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8690389"/>
              </p:ext>
            </p:extLst>
          </p:nvPr>
        </p:nvGraphicFramePr>
        <p:xfrm>
          <a:off x="3206516" y="1422400"/>
          <a:ext cx="8127993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u="none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u="none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u="sng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7" name="Tableau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1632985"/>
              </p:ext>
            </p:extLst>
          </p:nvPr>
        </p:nvGraphicFramePr>
        <p:xfrm>
          <a:off x="3206516" y="3446818"/>
          <a:ext cx="6361038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  <a:gridCol w="353391"/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u="sng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u="none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u="sng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u="none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b="1" u="sng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u="none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u="none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u="none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146204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4</TotalTime>
  <Words>183</Words>
  <Application>Microsoft Office PowerPoint</Application>
  <PresentationFormat>Personnalisé</PresentationFormat>
  <Paragraphs>3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ylene Ruh</dc:creator>
  <cp:lastModifiedBy>Nicolas Chen</cp:lastModifiedBy>
  <cp:revision>53</cp:revision>
  <dcterms:created xsi:type="dcterms:W3CDTF">2017-02-28T16:45:07Z</dcterms:created>
  <dcterms:modified xsi:type="dcterms:W3CDTF">2017-06-28T15:14:04Z</dcterms:modified>
</cp:coreProperties>
</file>